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61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megowda" initials="H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34" autoAdjust="0"/>
  </p:normalViewPr>
  <p:slideViewPr>
    <p:cSldViewPr snapToGrid="0">
      <p:cViewPr>
        <p:scale>
          <a:sx n="112" d="100"/>
          <a:sy n="112" d="100"/>
        </p:scale>
        <p:origin x="78" y="-762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3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12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8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6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83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01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98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52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346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7B6C6-404B-4981-9F27-BC98BFE8499D}" type="datetimeFigureOut">
              <a:rPr lang="en-US" smtClean="0"/>
              <a:t>9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2232" y="11388438"/>
            <a:ext cx="11194397" cy="255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. Functional classification of transcripts shared between individual drought and heat stress and their combination.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s from individual drought and drought-heat combination (CD), and individual heat and drought-heat combination (CH) studies were derived from transcriptome analysi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nctional classification of the transcripts based on biological processes. The analysis reveals that majority of  commonly regulated transcripts are involved in metabolic processes followed by stress responsive gene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nctional classification of the transcripts based on protein classes. The analysis reveals that majority of the transcripts commonly regulated between individual heat and combined heat-drought stress (CH) encode for chaperones followed by oxidoreductases. Transcripts common between individual drought and combined drought-heat stresses (CD) are equally represented by enzymes like oxidoreductases, hydrolases, and transferases. The genes were classified based on PANTHER classification system (http://www.pantherdb.org/geneListAnalysis.do). The figure is based on the analysis of data provid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izhsk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 (2004) Plant Physiol. 134 (4), 1683-1696.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4394" y="1607127"/>
            <a:ext cx="8459676" cy="9477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5166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>Upload</StageName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F58BFABD-BB3C-4B1F-80E1-6DF18B58EA11}"/>
</file>

<file path=customXml/itemProps2.xml><?xml version="1.0" encoding="utf-8"?>
<ds:datastoreItem xmlns:ds="http://schemas.openxmlformats.org/officeDocument/2006/customXml" ds:itemID="{41043542-50BE-4375-95CD-B2B64A6552E0}"/>
</file>

<file path=customXml/itemProps3.xml><?xml version="1.0" encoding="utf-8"?>
<ds:datastoreItem xmlns:ds="http://schemas.openxmlformats.org/officeDocument/2006/customXml" ds:itemID="{3BCB155D-BCFB-406A-B864-C092082CAD8F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2</TotalTime>
  <Words>15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45</cp:revision>
  <dcterms:created xsi:type="dcterms:W3CDTF">2015-06-03T08:23:24Z</dcterms:created>
  <dcterms:modified xsi:type="dcterms:W3CDTF">2015-09-03T12:0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